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9" y="8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39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336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130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732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82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746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737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946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501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439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246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4B1722-2D2C-412B-A426-E60834E15717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11B80-C986-4E60-B291-04F1A20EC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396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4070" y="618309"/>
            <a:ext cx="9254444" cy="528696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641684" y="5905274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8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deprotected chloroquinolines against sensitive strain W2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1060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5:58:55Z</dcterms:created>
  <dcterms:modified xsi:type="dcterms:W3CDTF">2020-08-04T16:32:04Z</dcterms:modified>
</cp:coreProperties>
</file>